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32" r:id="rId2"/>
    <p:sldId id="340" r:id="rId3"/>
  </p:sldIdLst>
  <p:sldSz cx="6858000" cy="9906000" type="A4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28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5" orient="horz" pos="17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TI" initials="N" lastIdx="1" clrIdx="0">
    <p:extLst>
      <p:ext uri="{19B8F6BF-5375-455C-9EA6-DF929625EA0E}">
        <p15:presenceInfo xmlns:p15="http://schemas.microsoft.com/office/powerpoint/2012/main" userId="NT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  <a:srgbClr val="FF33CC"/>
    <a:srgbClr val="CC99FF"/>
    <a:srgbClr val="E6B4E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918" autoAdjust="0"/>
    <p:restoredTop sz="93605" autoAdjust="0"/>
  </p:normalViewPr>
  <p:slideViewPr>
    <p:cSldViewPr snapToGrid="0">
      <p:cViewPr varScale="1">
        <p:scale>
          <a:sx n="83" d="100"/>
          <a:sy n="83" d="100"/>
        </p:scale>
        <p:origin x="3720" y="200"/>
      </p:cViewPr>
      <p:guideLst>
        <p:guide orient="horz" pos="3528"/>
        <p:guide pos="2160"/>
        <p:guide orient="horz" pos="17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4E5E2-2364-495B-8FEA-A94BDA5500A4}" type="datetimeFigureOut">
              <a:rPr lang="en-US" smtClean="0"/>
              <a:t>3/4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9C7DD8-F853-41C1-A918-3E163FAB79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453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620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1963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448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86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61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2744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10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668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29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375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67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087BB2-457A-46DA-9937-25E1CF408BA0}" type="datetimeFigureOut">
              <a:rPr lang="en-US" smtClean="0"/>
              <a:t>3/4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52D4E-420D-4790-B000-51C02F6A8A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33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164785" y="3828779"/>
            <a:ext cx="647308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sz="10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ure 1.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Uncropped images of Western blotting</a:t>
            </a:r>
            <a:r>
              <a:rPr lang="en-US" sz="1000" dirty="0">
                <a:solidFill>
                  <a:prstClr val="black"/>
                </a:solidFill>
              </a:rPr>
              <a:t> 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using antibodies against CYP11B1 (a), NR3C1 (b) and ACTB (c). The Images within yellow dotted area has been used in Figure 4C. Abbreviations: CC-Cumulus cell, GC- Granulosa cell</a:t>
            </a:r>
            <a:endParaRPr lang="en-US" sz="1000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5A2EE81-98D4-BD0B-FCCE-CBA49494761D}"/>
              </a:ext>
            </a:extLst>
          </p:cNvPr>
          <p:cNvGrpSpPr/>
          <p:nvPr/>
        </p:nvGrpSpPr>
        <p:grpSpPr>
          <a:xfrm>
            <a:off x="166242" y="1059017"/>
            <a:ext cx="6525516" cy="2552221"/>
            <a:chOff x="184174" y="1059017"/>
            <a:chExt cx="6525516" cy="2552221"/>
          </a:xfrm>
        </p:grpSpPr>
        <p:sp>
          <p:nvSpPr>
            <p:cNvPr id="8" name="TextBox 7"/>
            <p:cNvSpPr txBox="1"/>
            <p:nvPr/>
          </p:nvSpPr>
          <p:spPr>
            <a:xfrm>
              <a:off x="224946" y="3365017"/>
              <a:ext cx="19925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YP11B1 (55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599808" y="3365017"/>
              <a:ext cx="173921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R3C1 (94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274478" y="3365017"/>
              <a:ext cx="104708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>
                <a:defRPr/>
              </a:pP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B (42 </a:t>
              </a:r>
              <a:r>
                <a:rPr lang="en-US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Da</a:t>
              </a:r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D0C7255-C6D3-ED30-EE3F-650B2A4FB810}"/>
                </a:ext>
              </a:extLst>
            </p:cNvPr>
            <p:cNvGrpSpPr/>
            <p:nvPr/>
          </p:nvGrpSpPr>
          <p:grpSpPr>
            <a:xfrm>
              <a:off x="184174" y="1059017"/>
              <a:ext cx="6525516" cy="2289316"/>
              <a:chOff x="184174" y="1059017"/>
              <a:chExt cx="6525516" cy="2289316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5CE5415B-C3A8-91AC-6729-2B5955B15EB6}"/>
                  </a:ext>
                </a:extLst>
              </p:cNvPr>
              <p:cNvGrpSpPr/>
              <p:nvPr/>
            </p:nvGrpSpPr>
            <p:grpSpPr>
              <a:xfrm>
                <a:off x="184174" y="1059017"/>
                <a:ext cx="6525516" cy="2289316"/>
                <a:chOff x="205484" y="1038085"/>
                <a:chExt cx="6525516" cy="2289316"/>
              </a:xfrm>
            </p:grpSpPr>
            <p:sp>
              <p:nvSpPr>
                <p:cNvPr id="4" name="TextBox 3"/>
                <p:cNvSpPr txBox="1"/>
                <p:nvPr/>
              </p:nvSpPr>
              <p:spPr>
                <a:xfrm>
                  <a:off x="530867" y="1482837"/>
                  <a:ext cx="4931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</a:t>
                  </a:r>
                </a:p>
              </p:txBody>
            </p:sp>
            <p:sp>
              <p:nvSpPr>
                <p:cNvPr id="5" name="TextBox 4"/>
                <p:cNvSpPr txBox="1"/>
                <p:nvPr/>
              </p:nvSpPr>
              <p:spPr>
                <a:xfrm>
                  <a:off x="1605964" y="1482837"/>
                  <a:ext cx="4931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C</a:t>
                  </a:r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>
                  <a:off x="3842307" y="1482837"/>
                  <a:ext cx="68186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C</a:t>
                  </a:r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>
                  <a:off x="2905449" y="1482837"/>
                  <a:ext cx="51581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5963044" y="1482837"/>
                  <a:ext cx="4931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C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5077445" y="1482837"/>
                  <a:ext cx="4931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015532" y="1038085"/>
                  <a:ext cx="50156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a)</a:t>
                  </a: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3335779" y="1038085"/>
                  <a:ext cx="50156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b)</a:t>
                  </a: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5513900" y="1038085"/>
                  <a:ext cx="50156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c)</a:t>
                  </a:r>
                </a:p>
              </p:txBody>
            </p:sp>
            <p:grpSp>
              <p:nvGrpSpPr>
                <p:cNvPr id="31" name="Group 30"/>
                <p:cNvGrpSpPr/>
                <p:nvPr/>
              </p:nvGrpSpPr>
              <p:grpSpPr>
                <a:xfrm>
                  <a:off x="4686301" y="1752601"/>
                  <a:ext cx="2044699" cy="1574800"/>
                  <a:chOff x="2408767" y="4462441"/>
                  <a:chExt cx="2057400" cy="1472184"/>
                </a:xfrm>
              </p:grpSpPr>
              <p:pic>
                <p:nvPicPr>
                  <p:cNvPr id="29" name="Picture 28"/>
                  <p:cNvPicPr>
                    <a:picLocks noChangeAspect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408767" y="4462441"/>
                    <a:ext cx="2057400" cy="1472184"/>
                  </a:xfrm>
                  <a:prstGeom prst="rect">
                    <a:avLst/>
                  </a:prstGeom>
                </p:spPr>
              </p:pic>
              <p:sp>
                <p:nvSpPr>
                  <p:cNvPr id="30" name="Rounded Rectangle 29"/>
                  <p:cNvSpPr/>
                  <p:nvPr/>
                </p:nvSpPr>
                <p:spPr>
                  <a:xfrm>
                    <a:off x="2483111" y="4999236"/>
                    <a:ext cx="1869897" cy="217468"/>
                  </a:xfrm>
                  <a:prstGeom prst="roundRect">
                    <a:avLst/>
                  </a:prstGeom>
                  <a:noFill/>
                  <a:ln w="19050">
                    <a:solidFill>
                      <a:srgbClr val="FFFF0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37" name="Group 36"/>
                <p:cNvGrpSpPr/>
                <p:nvPr/>
              </p:nvGrpSpPr>
              <p:grpSpPr>
                <a:xfrm>
                  <a:off x="205484" y="1764570"/>
                  <a:ext cx="2037610" cy="1555786"/>
                  <a:chOff x="205484" y="1764570"/>
                  <a:chExt cx="2037610" cy="1555786"/>
                </a:xfrm>
              </p:grpSpPr>
              <p:pic>
                <p:nvPicPr>
                  <p:cNvPr id="2" name="Content Placeholder 4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0929" b="13775"/>
                  <a:stretch/>
                </p:blipFill>
                <p:spPr>
                  <a:xfrm>
                    <a:off x="205484" y="1764570"/>
                    <a:ext cx="2037610" cy="1555786"/>
                  </a:xfrm>
                  <a:prstGeom prst="rect">
                    <a:avLst/>
                  </a:prstGeom>
                </p:spPr>
              </p:pic>
              <p:sp>
                <p:nvSpPr>
                  <p:cNvPr id="32" name="Rounded Rectangle 31"/>
                  <p:cNvSpPr/>
                  <p:nvPr/>
                </p:nvSpPr>
                <p:spPr>
                  <a:xfrm>
                    <a:off x="262468" y="2226734"/>
                    <a:ext cx="1947332" cy="186266"/>
                  </a:xfrm>
                  <a:prstGeom prst="roundRect">
                    <a:avLst/>
                  </a:prstGeom>
                  <a:noFill/>
                  <a:ln w="19050">
                    <a:solidFill>
                      <a:srgbClr val="FFFF0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35" name="Group 34"/>
                <p:cNvGrpSpPr/>
                <p:nvPr/>
              </p:nvGrpSpPr>
              <p:grpSpPr>
                <a:xfrm>
                  <a:off x="2319189" y="1765883"/>
                  <a:ext cx="2278211" cy="1561516"/>
                  <a:chOff x="2039790" y="3662418"/>
                  <a:chExt cx="2304288" cy="1444506"/>
                </a:xfrm>
              </p:grpSpPr>
              <p:pic>
                <p:nvPicPr>
                  <p:cNvPr id="33" name="Picture 32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039790" y="3662418"/>
                    <a:ext cx="2304288" cy="1444506"/>
                  </a:xfrm>
                  <a:prstGeom prst="rect">
                    <a:avLst/>
                  </a:prstGeom>
                </p:spPr>
              </p:pic>
              <p:sp>
                <p:nvSpPr>
                  <p:cNvPr id="34" name="Rounded Rectangle 33"/>
                  <p:cNvSpPr/>
                  <p:nvPr/>
                </p:nvSpPr>
                <p:spPr>
                  <a:xfrm>
                    <a:off x="2192867" y="3924257"/>
                    <a:ext cx="960873" cy="207475"/>
                  </a:xfrm>
                  <a:prstGeom prst="roundRect">
                    <a:avLst/>
                  </a:prstGeom>
                  <a:noFill/>
                  <a:ln w="19050">
                    <a:solidFill>
                      <a:srgbClr val="FFFF00"/>
                    </a:solidFill>
                    <a:prstDash val="dash"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36" name="Rounded Rectangle 35"/>
              <p:cNvSpPr/>
              <p:nvPr/>
            </p:nvSpPr>
            <p:spPr>
              <a:xfrm>
                <a:off x="3579668" y="1981200"/>
                <a:ext cx="949999" cy="211667"/>
              </a:xfrm>
              <a:prstGeom prst="roundRect">
                <a:avLst/>
              </a:prstGeom>
              <a:noFill/>
              <a:ln w="19050">
                <a:solidFill>
                  <a:srgbClr val="FFFF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14469EA4-7D72-921F-E14D-09B7F8AF0E3C}"/>
              </a:ext>
            </a:extLst>
          </p:cNvPr>
          <p:cNvSpPr txBox="1"/>
          <p:nvPr/>
        </p:nvSpPr>
        <p:spPr>
          <a:xfrm>
            <a:off x="22483" y="151660"/>
            <a:ext cx="145536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.1 </a:t>
            </a:r>
            <a:endParaRPr lang="en-JP" sz="900" dirty="0"/>
          </a:p>
        </p:txBody>
      </p:sp>
    </p:spTree>
    <p:extLst>
      <p:ext uri="{BB962C8B-B14F-4D97-AF65-F5344CB8AC3E}">
        <p14:creationId xmlns:p14="http://schemas.microsoft.com/office/powerpoint/2010/main" val="42180311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TextBox 63">
            <a:extLst>
              <a:ext uri="{FF2B5EF4-FFF2-40B4-BE49-F238E27FC236}">
                <a16:creationId xmlns:a16="http://schemas.microsoft.com/office/drawing/2014/main" id="{E3EB2835-886E-4FAB-D603-BF3EC7238869}"/>
              </a:ext>
            </a:extLst>
          </p:cNvPr>
          <p:cNvSpPr txBox="1"/>
          <p:nvPr/>
        </p:nvSpPr>
        <p:spPr>
          <a:xfrm>
            <a:off x="461733" y="6885688"/>
            <a:ext cx="5987844" cy="28201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Comparative analysis of cytokine and chemokine expression profile of cumulus cells (CC) under </a:t>
            </a:r>
            <a:r>
              <a:rPr 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</a:t>
            </a:r>
            <a:r>
              <a:rPr lang="en-US" sz="9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</a:t>
            </a:r>
            <a:endParaRPr lang="en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6, Il7, Il-1</a:t>
            </a:r>
            <a:r>
              <a:rPr lang="el-GR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xcl1, Il10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rived CC at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8 h and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 h. Values are presented as the mean ± SEM of more than three independent experiments. Data were analyzed using an unpaired Student’s t-test. (b)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6, Il7, Il-1</a:t>
            </a:r>
            <a:r>
              <a:rPr lang="el-GR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xcl1, Il10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8 h IVM derived CC without corticosterone (0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, and with corticosterone (100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 and compare with baseline control 0 h (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8 h). Values are presented as the mean ± SEM of more than three independent experiments. Data were analyzed using one-way ANOVA followed by Tukey HSD post hoc test. Each gene expression was normalized to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l19.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ere considered statistically significant at p &lt; 0.05. Different lowercase letters indicate significant differences (p &lt; 0.05).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C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Equine chorionic gonadotropin, </a:t>
            </a:r>
            <a:r>
              <a:rPr lang="en-US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CG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uman chorionic gonadotropin, CC: Cumulus cell, IVM: </a:t>
            </a:r>
            <a:r>
              <a: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uration, h: Hours, SEM: Standard Error of the Mean, ns: non-significant (p &gt; 0.05). </a:t>
            </a:r>
            <a:endParaRPr lang="en-JP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9" name="Group 78">
            <a:extLst>
              <a:ext uri="{FF2B5EF4-FFF2-40B4-BE49-F238E27FC236}">
                <a16:creationId xmlns:a16="http://schemas.microsoft.com/office/drawing/2014/main" id="{487D3AB0-A902-DC37-C057-EC08F30049FF}"/>
              </a:ext>
            </a:extLst>
          </p:cNvPr>
          <p:cNvGrpSpPr/>
          <p:nvPr/>
        </p:nvGrpSpPr>
        <p:grpSpPr>
          <a:xfrm>
            <a:off x="1039871" y="345271"/>
            <a:ext cx="3807463" cy="3141615"/>
            <a:chOff x="1039871" y="345271"/>
            <a:chExt cx="3807463" cy="3141615"/>
          </a:xfrm>
        </p:grpSpPr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120E4497-1A31-0969-C4BE-54F25A91354A}"/>
                </a:ext>
              </a:extLst>
            </p:cNvPr>
            <p:cNvGrpSpPr/>
            <p:nvPr/>
          </p:nvGrpSpPr>
          <p:grpSpPr>
            <a:xfrm>
              <a:off x="1169883" y="345271"/>
              <a:ext cx="3677451" cy="3141615"/>
              <a:chOff x="712382" y="657363"/>
              <a:chExt cx="4235801" cy="3766257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712382" y="657363"/>
                <a:ext cx="4106038" cy="2272892"/>
                <a:chOff x="712382" y="657363"/>
                <a:chExt cx="4106038" cy="2272892"/>
              </a:xfrm>
            </p:grpSpPr>
            <p:grpSp>
              <p:nvGrpSpPr>
                <p:cNvPr id="49" name="Group 48"/>
                <p:cNvGrpSpPr/>
                <p:nvPr/>
              </p:nvGrpSpPr>
              <p:grpSpPr>
                <a:xfrm>
                  <a:off x="712382" y="657363"/>
                  <a:ext cx="4106038" cy="2272698"/>
                  <a:chOff x="692285" y="486541"/>
                  <a:chExt cx="3671060" cy="2232173"/>
                </a:xfrm>
              </p:grpSpPr>
              <p:sp>
                <p:nvSpPr>
                  <p:cNvPr id="10" name="TextBox 9"/>
                  <p:cNvSpPr txBox="1"/>
                  <p:nvPr/>
                </p:nvSpPr>
                <p:spPr>
                  <a:xfrm>
                    <a:off x="692285" y="486541"/>
                    <a:ext cx="501560" cy="2899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10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a)</a:t>
                    </a:r>
                  </a:p>
                </p:txBody>
              </p:sp>
              <p:grpSp>
                <p:nvGrpSpPr>
                  <p:cNvPr id="44" name="Group 43"/>
                  <p:cNvGrpSpPr/>
                  <p:nvPr/>
                </p:nvGrpSpPr>
                <p:grpSpPr>
                  <a:xfrm>
                    <a:off x="1344403" y="696134"/>
                    <a:ext cx="3018942" cy="2022580"/>
                    <a:chOff x="1621925" y="725520"/>
                    <a:chExt cx="3172856" cy="2121680"/>
                  </a:xfrm>
                </p:grpSpPr>
                <p:grpSp>
                  <p:nvGrpSpPr>
                    <p:cNvPr id="17" name="Group 16"/>
                    <p:cNvGrpSpPr/>
                    <p:nvPr/>
                  </p:nvGrpSpPr>
                  <p:grpSpPr>
                    <a:xfrm>
                      <a:off x="1621925" y="725520"/>
                      <a:ext cx="3172856" cy="304118"/>
                      <a:chOff x="1583825" y="725520"/>
                      <a:chExt cx="3172856" cy="304118"/>
                    </a:xfrm>
                  </p:grpSpPr>
                  <p:sp>
                    <p:nvSpPr>
                      <p:cNvPr id="11" name="TextBox 10"/>
                      <p:cNvSpPr txBox="1"/>
                      <p:nvPr/>
                    </p:nvSpPr>
                    <p:spPr>
                      <a:xfrm>
                        <a:off x="1583825" y="725520"/>
                        <a:ext cx="493156" cy="30411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 anchor="ctr">
                        <a:spAutoFit/>
                      </a:bodyPr>
                      <a:lstStyle/>
                      <a:p>
                        <a:pPr algn="ctr"/>
                        <a:r>
                          <a:rPr lang="en-US" sz="10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l6</a:t>
                        </a:r>
                      </a:p>
                    </p:txBody>
                  </p:sp>
                  <p:sp>
                    <p:nvSpPr>
                      <p:cNvPr id="12" name="TextBox 11"/>
                      <p:cNvSpPr txBox="1"/>
                      <p:nvPr/>
                    </p:nvSpPr>
                    <p:spPr>
                      <a:xfrm>
                        <a:off x="2879225" y="725520"/>
                        <a:ext cx="493156" cy="30411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 anchor="ctr">
                        <a:spAutoFit/>
                      </a:bodyPr>
                      <a:lstStyle/>
                      <a:p>
                        <a:pPr algn="ctr"/>
                        <a:r>
                          <a:rPr lang="en-US" sz="10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Il7</a:t>
                        </a:r>
                      </a:p>
                    </p:txBody>
                  </p:sp>
                  <p:sp>
                    <p:nvSpPr>
                      <p:cNvPr id="13" name="TextBox 12"/>
                      <p:cNvSpPr txBox="1"/>
                      <p:nvPr/>
                    </p:nvSpPr>
                    <p:spPr>
                      <a:xfrm>
                        <a:off x="4263525" y="733520"/>
                        <a:ext cx="493156" cy="28812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 anchor="ctr">
                        <a:spAutoFit/>
                      </a:bodyPr>
                      <a:lstStyle/>
                      <a:p>
                        <a:pPr algn="ctr">
                          <a:lnSpc>
                            <a:spcPct val="107000"/>
                          </a:lnSpc>
                          <a:spcAft>
                            <a:spcPts val="800"/>
                          </a:spcAft>
                        </a:pPr>
                        <a:r>
                          <a:rPr lang="en-US" altLang="ja-JP" sz="900" b="1" i="1" kern="100" dirty="0">
                            <a:solidFill>
                              <a:srgbClr val="000000"/>
                            </a:solidFill>
                            <a:latin typeface="Times New Roman" panose="02020603050405020304" pitchFamily="18" charset="0"/>
                            <a:ea typeface="游明朝" panose="02020400000000000000" pitchFamily="18" charset="-128"/>
                            <a:cs typeface="Times New Roman" panose="02020603050405020304" pitchFamily="18" charset="0"/>
                          </a:rPr>
                          <a:t>Il-1</a:t>
                        </a:r>
                        <a:r>
                          <a:rPr lang="el-GR" altLang="ja-JP" sz="900" b="1" i="1" kern="100" dirty="0">
                            <a:solidFill>
                              <a:srgbClr val="000000"/>
                            </a:solidFill>
                            <a:latin typeface="Times New Roman" panose="02020603050405020304" pitchFamily="18" charset="0"/>
                            <a:ea typeface="游明朝" panose="02020400000000000000" pitchFamily="18" charset="-128"/>
                            <a:cs typeface="Times New Roman" panose="02020603050405020304" pitchFamily="18" charset="0"/>
                          </a:rPr>
                          <a:t>β</a:t>
                        </a:r>
                        <a:endParaRPr lang="en-US" sz="1000" b="1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endParaRPr>
                      </a:p>
                    </p:txBody>
                  </p:sp>
                </p:grpSp>
                <p:sp>
                  <p:nvSpPr>
                    <p:cNvPr id="16" name="TextBox 15"/>
                    <p:cNvSpPr txBox="1"/>
                    <p:nvPr/>
                  </p:nvSpPr>
                  <p:spPr>
                    <a:xfrm>
                      <a:off x="3646958" y="2543477"/>
                      <a:ext cx="493156" cy="30372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10</a:t>
                      </a:r>
                      <a:endParaRPr lang="en-US" sz="1000" b="1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sp>
              <p:nvSpPr>
                <p:cNvPr id="51" name="TextBox 50"/>
                <p:cNvSpPr txBox="1"/>
                <p:nvPr/>
              </p:nvSpPr>
              <p:spPr>
                <a:xfrm>
                  <a:off x="2288015" y="2635078"/>
                  <a:ext cx="765908" cy="29517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sz="10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xcl1</a:t>
                  </a:r>
                </a:p>
              </p:txBody>
            </p:sp>
          </p:grpSp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79016465-F883-3C3A-808E-1C11ADD73C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073633" y="1131714"/>
                <a:ext cx="1344113" cy="1552131"/>
              </a:xfrm>
              <a:prstGeom prst="rect">
                <a:avLst/>
              </a:prstGeom>
            </p:spPr>
          </p:pic>
          <p:pic>
            <p:nvPicPr>
              <p:cNvPr id="54" name="Picture 53">
                <a:extLst>
                  <a:ext uri="{FF2B5EF4-FFF2-40B4-BE49-F238E27FC236}">
                    <a16:creationId xmlns:a16="http://schemas.microsoft.com/office/drawing/2014/main" id="{EBA57F63-84D8-F214-C580-D00A397AA0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604070" y="1139715"/>
                <a:ext cx="1344113" cy="1536129"/>
              </a:xfrm>
              <a:prstGeom prst="rect">
                <a:avLst/>
              </a:prstGeom>
            </p:spPr>
          </p:pic>
          <p:pic>
            <p:nvPicPr>
              <p:cNvPr id="55" name="Picture 54">
                <a:extLst>
                  <a:ext uri="{FF2B5EF4-FFF2-40B4-BE49-F238E27FC236}">
                    <a16:creationId xmlns:a16="http://schemas.microsoft.com/office/drawing/2014/main" id="{30C12E78-0883-97DD-DDFD-52F73D9B4CA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289453" y="1143715"/>
                <a:ext cx="1344113" cy="1528129"/>
              </a:xfrm>
              <a:prstGeom prst="rect">
                <a:avLst/>
              </a:prstGeom>
            </p:spPr>
          </p:pic>
          <p:pic>
            <p:nvPicPr>
              <p:cNvPr id="56" name="Picture 55">
                <a:extLst>
                  <a:ext uri="{FF2B5EF4-FFF2-40B4-BE49-F238E27FC236}">
                    <a16:creationId xmlns:a16="http://schemas.microsoft.com/office/drawing/2014/main" id="{58BBF885-4961-E9C1-D5AA-A26F7C82B4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818439" y="2895491"/>
                <a:ext cx="1344113" cy="1528129"/>
              </a:xfrm>
              <a:prstGeom prst="rect">
                <a:avLst/>
              </a:prstGeom>
            </p:spPr>
          </p:pic>
          <p:pic>
            <p:nvPicPr>
              <p:cNvPr id="57" name="Picture 56">
                <a:extLst>
                  <a:ext uri="{FF2B5EF4-FFF2-40B4-BE49-F238E27FC236}">
                    <a16:creationId xmlns:a16="http://schemas.microsoft.com/office/drawing/2014/main" id="{CF133D2E-F9AE-5933-0B9D-B8CA4FAD0D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53923" y="2899490"/>
                <a:ext cx="1384117" cy="1520128"/>
              </a:xfrm>
              <a:prstGeom prst="rect">
                <a:avLst/>
              </a:prstGeom>
            </p:spPr>
          </p:pic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DAA6397-2BAD-4F9F-77AB-ED47615676FD}"/>
                </a:ext>
              </a:extLst>
            </p:cNvPr>
            <p:cNvSpPr txBox="1"/>
            <p:nvPr/>
          </p:nvSpPr>
          <p:spPr>
            <a:xfrm rot="16200000">
              <a:off x="811252" y="2097761"/>
              <a:ext cx="7034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vivo</a:t>
              </a:r>
            </a:p>
          </p:txBody>
        </p: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6FA8EAAE-9A16-95E1-FAF8-F5C3B4DD0EBD}"/>
              </a:ext>
            </a:extLst>
          </p:cNvPr>
          <p:cNvGrpSpPr/>
          <p:nvPr/>
        </p:nvGrpSpPr>
        <p:grpSpPr>
          <a:xfrm>
            <a:off x="1039871" y="3533881"/>
            <a:ext cx="4300907" cy="3406353"/>
            <a:chOff x="1039871" y="3466686"/>
            <a:chExt cx="4300907" cy="3406353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758882CC-728B-F27E-B878-95D66C32BE84}"/>
                </a:ext>
              </a:extLst>
            </p:cNvPr>
            <p:cNvSpPr txBox="1"/>
            <p:nvPr/>
          </p:nvSpPr>
          <p:spPr>
            <a:xfrm rot="16200000">
              <a:off x="811252" y="5079864"/>
              <a:ext cx="7034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JP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vitro</a:t>
              </a:r>
            </a:p>
          </p:txBody>
        </p: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31622138-522A-D84C-52C8-4B075CAB9001}"/>
                </a:ext>
              </a:extLst>
            </p:cNvPr>
            <p:cNvGrpSpPr/>
            <p:nvPr/>
          </p:nvGrpSpPr>
          <p:grpSpPr>
            <a:xfrm>
              <a:off x="1295233" y="3466686"/>
              <a:ext cx="4045545" cy="3406353"/>
              <a:chOff x="1295233" y="3466686"/>
              <a:chExt cx="4045545" cy="3406353"/>
            </a:xfrm>
          </p:grpSpPr>
          <p:grpSp>
            <p:nvGrpSpPr>
              <p:cNvPr id="50" name="Group 49"/>
              <p:cNvGrpSpPr/>
              <p:nvPr/>
            </p:nvGrpSpPr>
            <p:grpSpPr>
              <a:xfrm>
                <a:off x="1295233" y="3466686"/>
                <a:ext cx="3805240" cy="1977577"/>
                <a:chOff x="904975" y="4738668"/>
                <a:chExt cx="3825028" cy="2333922"/>
              </a:xfrm>
            </p:grpSpPr>
            <p:sp>
              <p:nvSpPr>
                <p:cNvPr id="32" name="TextBox 31"/>
                <p:cNvSpPr txBox="1"/>
                <p:nvPr/>
              </p:nvSpPr>
              <p:spPr>
                <a:xfrm>
                  <a:off x="904975" y="4738668"/>
                  <a:ext cx="50156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b)</a:t>
                  </a:r>
                </a:p>
              </p:txBody>
            </p:sp>
            <p:grpSp>
              <p:nvGrpSpPr>
                <p:cNvPr id="48" name="Group 47"/>
                <p:cNvGrpSpPr/>
                <p:nvPr/>
              </p:nvGrpSpPr>
              <p:grpSpPr>
                <a:xfrm>
                  <a:off x="1641977" y="4840001"/>
                  <a:ext cx="3088026" cy="2232589"/>
                  <a:chOff x="1653744" y="4840437"/>
                  <a:chExt cx="3162734" cy="2373160"/>
                </a:xfrm>
              </p:grpSpPr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1653744" y="4840437"/>
                    <a:ext cx="3162734" cy="256993"/>
                    <a:chOff x="1583825" y="749083"/>
                    <a:chExt cx="3162734" cy="256993"/>
                  </a:xfrm>
                </p:grpSpPr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1583825" y="754469"/>
                      <a:ext cx="49315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r>
                        <a:rPr lang="en-US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6</a:t>
                      </a: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2879225" y="754469"/>
                      <a:ext cx="49315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r>
                        <a:rPr lang="en-US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7</a:t>
                      </a: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4253403" y="749083"/>
                      <a:ext cx="493156" cy="25699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ja-JP" sz="900" b="1" i="1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Il-1</a:t>
                      </a:r>
                      <a:r>
                        <a:rPr lang="el-GR" altLang="ja-JP" sz="900" b="1" i="1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β</a:t>
                      </a:r>
                      <a:endParaRPr lang="en-US" sz="1000" b="1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38" name="Group 37"/>
                  <p:cNvGrpSpPr/>
                  <p:nvPr/>
                </p:nvGrpSpPr>
                <p:grpSpPr>
                  <a:xfrm>
                    <a:off x="2147243" y="6919942"/>
                    <a:ext cx="1909806" cy="293655"/>
                    <a:chOff x="2233352" y="2537186"/>
                    <a:chExt cx="1909806" cy="293655"/>
                  </a:xfrm>
                </p:grpSpPr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2233352" y="2537186"/>
                      <a:ext cx="568298" cy="2936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r>
                        <a:rPr lang="en-US" sz="10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xcl1</a:t>
                      </a:r>
                    </a:p>
                  </p:txBody>
                </p:sp>
                <p:sp>
                  <p:nvSpPr>
                    <p:cNvPr id="41" name="TextBox 40"/>
                    <p:cNvSpPr txBox="1"/>
                    <p:nvPr/>
                  </p:nvSpPr>
                  <p:spPr>
                    <a:xfrm>
                      <a:off x="3650002" y="2551877"/>
                      <a:ext cx="493156" cy="26427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 anchor="ctr">
                      <a:spAutoFit/>
                    </a:bodyPr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i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l10</a:t>
                      </a:r>
                      <a:endParaRPr lang="en-US" sz="1000" b="1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462ECC8E-B012-BAF5-AD46-8F9E50F24A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2139975" y="5377527"/>
                <a:ext cx="1177301" cy="1475690"/>
              </a:xfrm>
              <a:prstGeom prst="rect">
                <a:avLst/>
              </a:prstGeom>
            </p:spPr>
          </p:pic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7F1CC3A1-D2B6-CD80-53C5-1C621B6498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243924" y="5357706"/>
                <a:ext cx="1265535" cy="1515333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8E69A63C-DDE3-0A3D-62DA-324EFFDB41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564827" y="3769285"/>
                <a:ext cx="1232337" cy="1489017"/>
              </a:xfrm>
              <a:prstGeom prst="rect">
                <a:avLst/>
              </a:prstGeom>
            </p:spPr>
          </p:pic>
          <p:pic>
            <p:nvPicPr>
              <p:cNvPr id="76" name="Picture 75">
                <a:extLst>
                  <a:ext uri="{FF2B5EF4-FFF2-40B4-BE49-F238E27FC236}">
                    <a16:creationId xmlns:a16="http://schemas.microsoft.com/office/drawing/2014/main" id="{81F82795-7572-7258-C2BF-C0822B78AF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772603" y="3769285"/>
                <a:ext cx="1265535" cy="1489017"/>
              </a:xfrm>
              <a:prstGeom prst="rect">
                <a:avLst/>
              </a:prstGeom>
            </p:spPr>
          </p:pic>
          <p:pic>
            <p:nvPicPr>
              <p:cNvPr id="77" name="Picture 76">
                <a:extLst>
                  <a:ext uri="{FF2B5EF4-FFF2-40B4-BE49-F238E27FC236}">
                    <a16:creationId xmlns:a16="http://schemas.microsoft.com/office/drawing/2014/main" id="{AD425282-293A-8FEA-51CB-A7EBC05BB29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075243" y="3756127"/>
                <a:ext cx="1265535" cy="1515333"/>
              </a:xfrm>
              <a:prstGeom prst="rect">
                <a:avLst/>
              </a:prstGeom>
            </p:spPr>
          </p:pic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690CDF2-4465-1564-DB08-05D6AA899CB8}"/>
              </a:ext>
            </a:extLst>
          </p:cNvPr>
          <p:cNvSpPr txBox="1"/>
          <p:nvPr/>
        </p:nvSpPr>
        <p:spPr>
          <a:xfrm>
            <a:off x="22483" y="151660"/>
            <a:ext cx="145536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ry Fig.2 </a:t>
            </a:r>
            <a:endParaRPr lang="en-JP" sz="900" dirty="0"/>
          </a:p>
        </p:txBody>
      </p:sp>
    </p:spTree>
    <p:extLst>
      <p:ext uri="{BB962C8B-B14F-4D97-AF65-F5344CB8AC3E}">
        <p14:creationId xmlns:p14="http://schemas.microsoft.com/office/powerpoint/2010/main" val="2521765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438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C76500D1-76E2-4295-BDE8-0D8A6459AAC8}">
  <we:reference id="wa200005566" version="3.0.0.2" store="en-US" storeType="OMEX"/>
  <we:alternateReferences>
    <we:reference id="wa200005566" version="3.0.0.2" store="wa200005566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157</TotalTime>
  <Words>338</Words>
  <Application>Microsoft Macintosh PowerPoint</Application>
  <PresentationFormat>A4 210 x 297 mm</PresentationFormat>
  <Paragraphs>3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2013 - 2022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山中　貴寛</cp:lastModifiedBy>
  <cp:revision>516</cp:revision>
  <cp:lastPrinted>2025-06-10T12:43:45Z</cp:lastPrinted>
  <dcterms:created xsi:type="dcterms:W3CDTF">2024-11-07T01:45:00Z</dcterms:created>
  <dcterms:modified xsi:type="dcterms:W3CDTF">2026-03-03T15:50:57Z</dcterms:modified>
</cp:coreProperties>
</file>